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931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1D50A-45FA-4FC9-A731-27D62CAC31CA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37871-9CBB-4E17-B92E-CDD75737BB7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1D50A-45FA-4FC9-A731-27D62CAC31CA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37871-9CBB-4E17-B92E-CDD75737BB7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1D50A-45FA-4FC9-A731-27D62CAC31CA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37871-9CBB-4E17-B92E-CDD75737BB7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1D50A-45FA-4FC9-A731-27D62CAC31CA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37871-9CBB-4E17-B92E-CDD75737BB7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1D50A-45FA-4FC9-A731-27D62CAC31CA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37871-9CBB-4E17-B92E-CDD75737BB7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1D50A-45FA-4FC9-A731-27D62CAC31CA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37871-9CBB-4E17-B92E-CDD75737BB7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1D50A-45FA-4FC9-A731-27D62CAC31CA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37871-9CBB-4E17-B92E-CDD75737BB7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1D50A-45FA-4FC9-A731-27D62CAC31CA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37871-9CBB-4E17-B92E-CDD75737BB7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1D50A-45FA-4FC9-A731-27D62CAC31CA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37871-9CBB-4E17-B92E-CDD75737BB7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1D50A-45FA-4FC9-A731-27D62CAC31CA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37871-9CBB-4E17-B92E-CDD75737BB7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1D50A-45FA-4FC9-A731-27D62CAC31CA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37871-9CBB-4E17-B92E-CDD75737BB7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21D50A-45FA-4FC9-A731-27D62CAC31CA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837871-9CBB-4E17-B92E-CDD75737BB7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85738" y="116632"/>
            <a:ext cx="8770937" cy="48085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ZoneTexte 4"/>
          <p:cNvSpPr txBox="1"/>
          <p:nvPr/>
        </p:nvSpPr>
        <p:spPr>
          <a:xfrm>
            <a:off x="323528" y="5157192"/>
            <a:ext cx="864096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Additional file 6</a:t>
            </a:r>
            <a:r>
              <a:rPr lang="en-US" sz="1200" dirty="0"/>
              <a:t>: </a:t>
            </a:r>
            <a:r>
              <a:rPr lang="en-US" sz="1200" b="1" dirty="0"/>
              <a:t>MA plot representations of </a:t>
            </a:r>
            <a:r>
              <a:rPr lang="en-US" sz="1200" b="1" dirty="0" err="1"/>
              <a:t>RNAseq</a:t>
            </a:r>
            <a:r>
              <a:rPr lang="en-US" sz="1200" b="1" dirty="0"/>
              <a:t> data</a:t>
            </a:r>
            <a:r>
              <a:rPr lang="en-US" sz="1200" dirty="0"/>
              <a:t>. MA plot representing the differential expression obtained for </a:t>
            </a:r>
            <a:r>
              <a:rPr lang="en-US" sz="1200" dirty="0" smtClean="0"/>
              <a:t>STM 2683 </a:t>
            </a:r>
            <a:r>
              <a:rPr lang="en-US" sz="1200" dirty="0"/>
              <a:t>(A and C) and </a:t>
            </a:r>
            <a:r>
              <a:rPr lang="en-US" sz="1200" dirty="0" smtClean="0"/>
              <a:t>STM 4661 </a:t>
            </a:r>
            <a:r>
              <a:rPr lang="en-US" sz="1200" dirty="0"/>
              <a:t>(B and D) for each metal </a:t>
            </a:r>
            <a:r>
              <a:rPr lang="en-US" sz="1200" i="1" dirty="0" err="1"/>
              <a:t>vs</a:t>
            </a:r>
            <a:r>
              <a:rPr lang="en-US" sz="1200" dirty="0"/>
              <a:t> control experiment. Mean read numbers for the compared treatments Zinc </a:t>
            </a:r>
            <a:r>
              <a:rPr lang="en-US" sz="1200" i="1" dirty="0" err="1"/>
              <a:t>vs</a:t>
            </a:r>
            <a:r>
              <a:rPr lang="en-US" sz="1200" i="1" dirty="0"/>
              <a:t> </a:t>
            </a:r>
            <a:r>
              <a:rPr lang="en-US" sz="1200" dirty="0"/>
              <a:t>Control (A and B) or Cadmium </a:t>
            </a:r>
            <a:r>
              <a:rPr lang="en-US" sz="1200" i="1" dirty="0" err="1"/>
              <a:t>vs</a:t>
            </a:r>
            <a:r>
              <a:rPr lang="en-US" sz="1200" dirty="0"/>
              <a:t> Control (C and D)  for each predicted CDS are reported on the X axes and plotted against their respective log </a:t>
            </a:r>
            <a:r>
              <a:rPr lang="en-US" sz="1200" dirty="0" smtClean="0"/>
              <a:t>2 transformed </a:t>
            </a:r>
            <a:r>
              <a:rPr lang="en-US" sz="1200" dirty="0"/>
              <a:t>fold changes on the Y axes. Red stars refer to CDS with a </a:t>
            </a:r>
            <a:r>
              <a:rPr lang="en-US" sz="1200" dirty="0" err="1"/>
              <a:t>padj</a:t>
            </a:r>
            <a:r>
              <a:rPr lang="en-US" sz="1200" dirty="0"/>
              <a:t> value below 0.1. </a:t>
            </a:r>
            <a:endParaRPr lang="fr-FR" sz="1200" dirty="0"/>
          </a:p>
          <a:p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02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RD Montpellie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LE QUERE ANTOINE</dc:creator>
  <cp:lastModifiedBy>LE QUERE ANTOINE</cp:lastModifiedBy>
  <cp:revision>3</cp:revision>
  <dcterms:created xsi:type="dcterms:W3CDTF">2012-11-12T16:21:03Z</dcterms:created>
  <dcterms:modified xsi:type="dcterms:W3CDTF">2013-03-22T16:54:27Z</dcterms:modified>
</cp:coreProperties>
</file>